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D4971"/>
    <a:srgbClr val="33BCB7"/>
    <a:srgbClr val="30BC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0" d="100"/>
          <a:sy n="70" d="100"/>
        </p:scale>
        <p:origin x="8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yn Ragsdale" userId="006a1076-9afb-4345-acc2-efc09894358d" providerId="ADAL" clId="{8FD13883-3E1D-4178-80D9-F0B4F3B2B13F}"/>
    <pc:docChg chg="modSld">
      <pc:chgData name="Carolyn Ragsdale" userId="006a1076-9afb-4345-acc2-efc09894358d" providerId="ADAL" clId="{8FD13883-3E1D-4178-80D9-F0B4F3B2B13F}" dt="2022-04-11T17:01:48.964" v="2" actId="1076"/>
      <pc:docMkLst>
        <pc:docMk/>
      </pc:docMkLst>
      <pc:sldChg chg="modSp mod">
        <pc:chgData name="Carolyn Ragsdale" userId="006a1076-9afb-4345-acc2-efc09894358d" providerId="ADAL" clId="{8FD13883-3E1D-4178-80D9-F0B4F3B2B13F}" dt="2022-04-11T17:01:48.964" v="2" actId="1076"/>
        <pc:sldMkLst>
          <pc:docMk/>
          <pc:sldMk cId="2835615971" sldId="256"/>
        </pc:sldMkLst>
        <pc:spChg chg="mod">
          <ac:chgData name="Carolyn Ragsdale" userId="006a1076-9afb-4345-acc2-efc09894358d" providerId="ADAL" clId="{8FD13883-3E1D-4178-80D9-F0B4F3B2B13F}" dt="2022-04-11T17:01:34.081" v="1" actId="1076"/>
          <ac:spMkLst>
            <pc:docMk/>
            <pc:sldMk cId="2835615971" sldId="256"/>
            <ac:spMk id="42" creationId="{6C178072-E023-4DCD-A836-B14844B515F4}"/>
          </ac:spMkLst>
        </pc:spChg>
        <pc:spChg chg="mod">
          <ac:chgData name="Carolyn Ragsdale" userId="006a1076-9afb-4345-acc2-efc09894358d" providerId="ADAL" clId="{8FD13883-3E1D-4178-80D9-F0B4F3B2B13F}" dt="2022-04-11T17:01:48.964" v="2" actId="1076"/>
          <ac:spMkLst>
            <pc:docMk/>
            <pc:sldMk cId="2835615971" sldId="256"/>
            <ac:spMk id="45" creationId="{D4F27A42-461E-47EC-A4CA-0271E1646E44}"/>
          </ac:spMkLst>
        </pc:spChg>
        <pc:spChg chg="mod">
          <ac:chgData name="Carolyn Ragsdale" userId="006a1076-9afb-4345-acc2-efc09894358d" providerId="ADAL" clId="{8FD13883-3E1D-4178-80D9-F0B4F3B2B13F}" dt="2022-04-11T17:01:32.092" v="0" actId="1076"/>
          <ac:spMkLst>
            <pc:docMk/>
            <pc:sldMk cId="2835615971" sldId="256"/>
            <ac:spMk id="46" creationId="{24FC4E8F-3124-4036-9816-9EBA28B0A15C}"/>
          </ac:spMkLst>
        </pc:spChg>
      </pc:sldChg>
    </pc:docChg>
  </pc:docChgLst>
  <pc:docChgLst>
    <pc:chgData name="Carolyn Ragsdale" userId="006a1076-9afb-4345-acc2-efc09894358d" providerId="ADAL" clId="{6D945C82-B497-4AD6-98FA-62E40FBB5164}"/>
    <pc:docChg chg="modSld">
      <pc:chgData name="Carolyn Ragsdale" userId="006a1076-9afb-4345-acc2-efc09894358d" providerId="ADAL" clId="{6D945C82-B497-4AD6-98FA-62E40FBB5164}" dt="2022-07-28T19:05:53.387" v="1" actId="20577"/>
      <pc:docMkLst>
        <pc:docMk/>
      </pc:docMkLst>
      <pc:sldChg chg="modSp mod">
        <pc:chgData name="Carolyn Ragsdale" userId="006a1076-9afb-4345-acc2-efc09894358d" providerId="ADAL" clId="{6D945C82-B497-4AD6-98FA-62E40FBB5164}" dt="2022-07-28T19:05:53.387" v="1" actId="20577"/>
        <pc:sldMkLst>
          <pc:docMk/>
          <pc:sldMk cId="2835615971" sldId="256"/>
        </pc:sldMkLst>
        <pc:spChg chg="mod">
          <ac:chgData name="Carolyn Ragsdale" userId="006a1076-9afb-4345-acc2-efc09894358d" providerId="ADAL" clId="{6D945C82-B497-4AD6-98FA-62E40FBB5164}" dt="2022-07-28T19:05:53.387" v="1" actId="20577"/>
          <ac:spMkLst>
            <pc:docMk/>
            <pc:sldMk cId="2835615971" sldId="256"/>
            <ac:spMk id="10" creationId="{61E39EC0-03C3-41AC-AE56-8AA8F68528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8F53E-9FD4-48AD-8CB9-17E60DAB9C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D429B7-E1E9-40F2-B5B6-8D0C62A63C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5C4B5-F8C6-4159-981B-DB32D5695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C83F26-A74A-48ED-B9D9-CE317FC4C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CC7845-2103-4EA6-9236-BD21CA0D1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962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79251-14BB-438D-8291-1D16E81BA2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368CDC-FD62-4A6B-A941-A59AC73D31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A9FF5-B1B0-450E-9DCE-FC7B8C4D5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329776-024C-4858-9627-A0632A946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511A56-8D82-413B-9E38-1516649BE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765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5BA82B6-A24B-47A4-ACF2-1B59646AE0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BDF558-0A36-4016-BA2E-FAB713348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D14F2-940D-4777-BD95-C78D3518F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79736-AB10-4BFA-BADD-36DB8CB20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DC332-A4A6-49C6-89DC-6E545C230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03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E911DB-7392-4DB9-A498-B27A5F7A3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0FB909-157A-4101-9C73-D9818EE074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23BF5-0C4C-47D1-9A6C-E473BD082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AB6EE-68E5-46F9-86AE-D5CBD2186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E4C82-9AC5-44E2-B9EE-0386A9519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06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EDC7D-8D1C-4C95-806A-E1ACFD57F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AB89B6-3EBF-471B-AA5D-902BA8955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FEC14A-4AF0-4D3D-9F44-EF1A682C0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376EA4-1A30-4ACE-90DC-80701F124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0B32B-55E7-449A-84A2-144FF51BC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450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94335-D01F-4292-9DF1-B9D8C7D044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86C07F-DDEB-4051-9514-2310D78E01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4345CE-308F-4A51-A6CE-843843E69B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F6C0BB-BB17-44CE-A2B5-2F7F34B9D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E5B6AD-0157-4648-B97C-1DE8BA780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5CA090-7DD6-4BD0-B65A-0327EB827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09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C7B3A-C9F5-41C4-A78B-DA7544150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067E47-B30F-4AA9-A28D-88A33DA07B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CF32E6-1997-451F-9FF6-0897E7CE0C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BE0054-1C89-4EBF-B6EA-525B4449F9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D6F6DF-90DD-4164-A5BE-2639869FEA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C4D8BA-94B3-45B8-8C6A-4E5319962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DC1246-26FE-452A-B4AD-35BBEDE1F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95DAF4-5556-40EA-8FE1-E13949369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31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C0F5AF-90F1-414B-BCC5-F5C20CB0D4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59AE8D-A591-4267-AE7C-481A2FC16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B9CBB4-2EDF-4371-B54B-EE707CC31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4674E6-5EC9-44E4-B4C9-C4CD17CB1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557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56BFDF-5ECC-4CCA-9ED3-D2F2FED6C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BE3700-5ECA-4DF6-8D54-BD028069C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632831-B75E-4145-9664-185090DB5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721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96BFF-980E-42B9-8A91-9C037CCDF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E5F854-ABAA-44ED-A1BB-E8CEED2E7F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D46281-0759-4FCE-AB9C-694E5F2161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8DBAD4-5FE9-46D3-9CDA-99ECAF54E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FC3FF4-1241-43CD-A51E-064ED34A1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15B069-5E93-4751-838D-21E501027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42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2D28E-0CDC-418C-88DA-5EF7F2620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AF6234-304C-431B-9A72-C1335DF1CF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D5B634-960C-4C79-A0C5-7942D1E42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F8F10A-1AFE-4F0E-9B48-839988EC9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CEC1B-D4F4-4BAE-A200-FD9420EE1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EA6D0A-4E31-497E-AC00-9D9900344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921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258016-AE98-46A9-A428-2C45314C3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8E65B-F45A-44AA-B6D2-02FB9651DF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988671-54A2-4983-A9C1-9590A2D97E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444B0-B46C-4DAC-9122-803A4FED3262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2CFA24-A30D-4B41-9187-CA60DD1FE4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BD7775-5FB5-467F-A5A3-46250C406B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2367E-BF85-48E8-8A34-0FE75C8CF0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978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1E39EC0-03C3-41AC-AE56-8AA8F6852815}"/>
              </a:ext>
            </a:extLst>
          </p:cNvPr>
          <p:cNvSpPr txBox="1"/>
          <p:nvPr/>
        </p:nvSpPr>
        <p:spPr>
          <a:xfrm>
            <a:off x="736978" y="299195"/>
            <a:ext cx="1034500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nhaled Sargramostim (rhu GM-CSF) for COVID-19-Associated Acute Hypoxemia:</a:t>
            </a:r>
          </a:p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Results of the Phase 2, Randomized, Open-Label Trial</a:t>
            </a:r>
          </a:p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(iLeukPulm)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0541600D-F415-46AE-8F0C-00F5E987BF7E}"/>
              </a:ext>
            </a:extLst>
          </p:cNvPr>
          <p:cNvGrpSpPr/>
          <p:nvPr/>
        </p:nvGrpSpPr>
        <p:grpSpPr>
          <a:xfrm>
            <a:off x="485714" y="1460286"/>
            <a:ext cx="11388048" cy="1777730"/>
            <a:chOff x="158169" y="2209652"/>
            <a:chExt cx="11388048" cy="177773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093FAB5-FE23-4038-A414-72D2B8A1B728}"/>
                </a:ext>
              </a:extLst>
            </p:cNvPr>
            <p:cNvGrpSpPr/>
            <p:nvPr/>
          </p:nvGrpSpPr>
          <p:grpSpPr>
            <a:xfrm>
              <a:off x="3411939" y="2209652"/>
              <a:ext cx="8134278" cy="1777730"/>
              <a:chOff x="657564" y="1158474"/>
              <a:chExt cx="8092277" cy="1777730"/>
            </a:xfrm>
          </p:grpSpPr>
          <p:sp>
            <p:nvSpPr>
              <p:cNvPr id="5" name="Rounded Rectangle 4">
                <a:extLst>
                  <a:ext uri="{FF2B5EF4-FFF2-40B4-BE49-F238E27FC236}">
                    <a16:creationId xmlns:a16="http://schemas.microsoft.com/office/drawing/2014/main" id="{69C0001C-6778-4CB1-905F-B9A9C810F8F7}"/>
                  </a:ext>
                </a:extLst>
              </p:cNvPr>
              <p:cNvSpPr/>
              <p:nvPr/>
            </p:nvSpPr>
            <p:spPr>
              <a:xfrm>
                <a:off x="3495009" y="1158474"/>
                <a:ext cx="5254832" cy="923330"/>
              </a:xfrm>
              <a:prstGeom prst="rect">
                <a:avLst/>
              </a:prstGeom>
              <a:gradFill rotWithShape="1">
                <a:gsLst>
                  <a:gs pos="0">
                    <a:srgbClr val="3CB5B1">
                      <a:shade val="85000"/>
                      <a:satMod val="130000"/>
                    </a:srgbClr>
                  </a:gs>
                  <a:gs pos="34000">
                    <a:srgbClr val="3CB5B1">
                      <a:shade val="87000"/>
                      <a:satMod val="125000"/>
                    </a:srgbClr>
                  </a:gs>
                  <a:gs pos="70000">
                    <a:srgbClr val="3CB5B1">
                      <a:tint val="100000"/>
                      <a:shade val="90000"/>
                      <a:satMod val="130000"/>
                    </a:srgbClr>
                  </a:gs>
                  <a:gs pos="100000">
                    <a:srgbClr val="3CB5B1">
                      <a:tint val="100000"/>
                      <a:shade val="100000"/>
                      <a:satMod val="110000"/>
                    </a:srgbClr>
                  </a:gs>
                </a:gsLst>
                <a:path path="circle">
                  <a:fillToRect l="100000" t="100000" r="100000" b="100000"/>
                </a:path>
              </a:gradFill>
              <a:ln w="12700" cap="flat" cmpd="sng" algn="ctr">
                <a:solidFill>
                  <a:srgbClr val="3CB5B1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6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Sargramostim Arm (n = 78)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Sargramostim 125 mcg inhaled twice daily for up to 5 days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6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+ Institutional SOC</a:t>
                </a:r>
              </a:p>
            </p:txBody>
          </p:sp>
          <p:sp>
            <p:nvSpPr>
              <p:cNvPr id="6" name="Rounded Rectangle 5">
                <a:extLst>
                  <a:ext uri="{FF2B5EF4-FFF2-40B4-BE49-F238E27FC236}">
                    <a16:creationId xmlns:a16="http://schemas.microsoft.com/office/drawing/2014/main" id="{A8267BD2-4A73-4367-9B9E-F8EA9608D48C}"/>
                  </a:ext>
                </a:extLst>
              </p:cNvPr>
              <p:cNvSpPr/>
              <p:nvPr/>
            </p:nvSpPr>
            <p:spPr>
              <a:xfrm>
                <a:off x="3495009" y="2276143"/>
                <a:ext cx="5254832" cy="660061"/>
              </a:xfrm>
              <a:prstGeom prst="rect">
                <a:avLst/>
              </a:prstGeom>
              <a:solidFill>
                <a:srgbClr val="30BCB8"/>
              </a:solidFill>
              <a:ln w="12700" cap="flat" cmpd="sng" algn="ctr">
                <a:solidFill>
                  <a:srgbClr val="3CB5B1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6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SOC Arm (n = 44)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6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Institutional SOC alone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16D1F4A5-A813-4C6B-BA73-B78929D048BF}"/>
                  </a:ext>
                </a:extLst>
              </p:cNvPr>
              <p:cNvSpPr/>
              <p:nvPr/>
            </p:nvSpPr>
            <p:spPr>
              <a:xfrm>
                <a:off x="657564" y="1620139"/>
                <a:ext cx="2158790" cy="1058664"/>
              </a:xfrm>
              <a:prstGeom prst="rect">
                <a:avLst/>
              </a:prstGeom>
              <a:solidFill>
                <a:srgbClr val="1D4971"/>
              </a:solidFill>
              <a:ln w="15875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Stratification: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"/>
                  <a:ea typeface="+mn-ea"/>
                  <a:cs typeface="+mn-cs"/>
                </a:endParaRPr>
              </a:p>
              <a:p>
                <a:pPr marL="176213" marR="0" lvl="0" indent="-176213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+mj-lt"/>
                  <a:buAutoNum type="arabicPeriod"/>
                  <a:tabLst/>
                  <a:defRPr/>
                </a:pPr>
                <a:r>
                  <a:rPr kumimoji="0" 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SOFA score (&lt;6 vs ≥6)</a:t>
                </a:r>
              </a:p>
              <a:p>
                <a:pPr marL="176213" marR="0" lvl="0" indent="-176213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+mj-lt"/>
                  <a:buAutoNum type="arabicPeriod"/>
                  <a:tabLst/>
                  <a:defRPr/>
                </a:pPr>
                <a:r>
                  <a:rPr kumimoji="0" 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Arial"/>
                    <a:ea typeface="+mn-ea"/>
                    <a:cs typeface="+mn-cs"/>
                  </a:rPr>
                  <a:t>Investigational site</a:t>
                </a:r>
              </a:p>
            </p:txBody>
          </p:sp>
          <p:cxnSp>
            <p:nvCxnSpPr>
              <p:cNvPr id="8" name="Elbow Connector 9">
                <a:extLst>
                  <a:ext uri="{FF2B5EF4-FFF2-40B4-BE49-F238E27FC236}">
                    <a16:creationId xmlns:a16="http://schemas.microsoft.com/office/drawing/2014/main" id="{11F8D290-4971-412D-9D99-6456F30C8026}"/>
                  </a:ext>
                </a:extLst>
              </p:cNvPr>
              <p:cNvCxnSpPr>
                <a:cxnSpLocks/>
                <a:stCxn id="7" idx="3"/>
                <a:endCxn id="5" idx="1"/>
              </p:cNvCxnSpPr>
              <p:nvPr/>
            </p:nvCxnSpPr>
            <p:spPr>
              <a:xfrm flipV="1">
                <a:off x="2816354" y="1620139"/>
                <a:ext cx="678655" cy="529332"/>
              </a:xfrm>
              <a:prstGeom prst="bentConnector3">
                <a:avLst>
                  <a:gd name="adj1" fmla="val 50000"/>
                </a:avLst>
              </a:prstGeom>
              <a:noFill/>
              <a:ln w="38100" cap="flat" cmpd="sng" algn="ctr">
                <a:solidFill>
                  <a:srgbClr val="1D4971"/>
                </a:solidFill>
                <a:prstDash val="solid"/>
                <a:tailEnd type="triangle"/>
              </a:ln>
              <a:effectLst/>
            </p:spPr>
          </p:cxnSp>
          <p:cxnSp>
            <p:nvCxnSpPr>
              <p:cNvPr id="9" name="Elbow Connector 11">
                <a:extLst>
                  <a:ext uri="{FF2B5EF4-FFF2-40B4-BE49-F238E27FC236}">
                    <a16:creationId xmlns:a16="http://schemas.microsoft.com/office/drawing/2014/main" id="{5088FED7-DD6E-4E58-B211-951147744DEF}"/>
                  </a:ext>
                </a:extLst>
              </p:cNvPr>
              <p:cNvCxnSpPr>
                <a:cxnSpLocks/>
                <a:stCxn id="7" idx="3"/>
                <a:endCxn id="6" idx="1"/>
              </p:cNvCxnSpPr>
              <p:nvPr/>
            </p:nvCxnSpPr>
            <p:spPr>
              <a:xfrm>
                <a:off x="2816354" y="2149471"/>
                <a:ext cx="678655" cy="456703"/>
              </a:xfrm>
              <a:prstGeom prst="bentConnector3">
                <a:avLst>
                  <a:gd name="adj1" fmla="val 50000"/>
                </a:avLst>
              </a:prstGeom>
              <a:noFill/>
              <a:ln w="38100" cap="flat" cmpd="sng" algn="ctr">
                <a:solidFill>
                  <a:srgbClr val="1D4971"/>
                </a:solidFill>
                <a:prstDash val="solid"/>
                <a:tailEnd type="triangle"/>
              </a:ln>
              <a:effectLst/>
            </p:spPr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BCC420F-4E3A-4E7B-983B-A61129A73721}"/>
                </a:ext>
              </a:extLst>
            </p:cNvPr>
            <p:cNvSpPr txBox="1"/>
            <p:nvPr/>
          </p:nvSpPr>
          <p:spPr>
            <a:xfrm>
              <a:off x="158169" y="2575886"/>
              <a:ext cx="2571593" cy="120032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ospitalized adults with COVID-19-associated hypoxemia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O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aturation &lt;93% on ≥2 L/min oxygen and/or PaO2/FiO2 &lt;350) </a:t>
              </a:r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2805FCC2-0673-4F5C-874F-F1AC3C1139A8}"/>
                </a:ext>
              </a:extLst>
            </p:cNvPr>
            <p:cNvCxnSpPr>
              <a:cxnSpLocks/>
            </p:cNvCxnSpPr>
            <p:nvPr/>
          </p:nvCxnSpPr>
          <p:spPr>
            <a:xfrm>
              <a:off x="2729762" y="3253891"/>
              <a:ext cx="682177" cy="5984"/>
            </a:xfrm>
            <a:prstGeom prst="straightConnector1">
              <a:avLst/>
            </a:prstGeom>
            <a:ln w="38100">
              <a:solidFill>
                <a:srgbClr val="1D497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3F043A13-0BFF-474E-9797-75901DF8EF07}"/>
              </a:ext>
            </a:extLst>
          </p:cNvPr>
          <p:cNvSpPr txBox="1"/>
          <p:nvPr/>
        </p:nvSpPr>
        <p:spPr>
          <a:xfrm>
            <a:off x="2458226" y="3413728"/>
            <a:ext cx="2792683" cy="400110"/>
          </a:xfrm>
          <a:prstGeom prst="rect">
            <a:avLst/>
          </a:prstGeom>
          <a:ln>
            <a:solidFill>
              <a:srgbClr val="1D497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1D497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Outcome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59C0CCA-B682-4BDF-A6A4-8E68A1DC7038}"/>
              </a:ext>
            </a:extLst>
          </p:cNvPr>
          <p:cNvSpPr txBox="1"/>
          <p:nvPr/>
        </p:nvSpPr>
        <p:spPr>
          <a:xfrm>
            <a:off x="7767933" y="3429000"/>
            <a:ext cx="2292767" cy="400110"/>
          </a:xfrm>
          <a:prstGeom prst="rect">
            <a:avLst/>
          </a:prstGeom>
          <a:ln>
            <a:solidFill>
              <a:srgbClr val="1D497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1D497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fety Outcomes</a:t>
            </a:r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22357D6A-3A16-4C19-93E5-9169D645735A}"/>
              </a:ext>
            </a:extLst>
          </p:cNvPr>
          <p:cNvSpPr/>
          <p:nvPr/>
        </p:nvSpPr>
        <p:spPr>
          <a:xfrm>
            <a:off x="2458226" y="3821287"/>
            <a:ext cx="358757" cy="502037"/>
          </a:xfrm>
          <a:prstGeom prst="downArrow">
            <a:avLst/>
          </a:prstGeom>
          <a:solidFill>
            <a:srgbClr val="1D497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Arrow: Down 41">
            <a:extLst>
              <a:ext uri="{FF2B5EF4-FFF2-40B4-BE49-F238E27FC236}">
                <a16:creationId xmlns:a16="http://schemas.microsoft.com/office/drawing/2014/main" id="{6C178072-E023-4DCD-A836-B14844B515F4}"/>
              </a:ext>
            </a:extLst>
          </p:cNvPr>
          <p:cNvSpPr/>
          <p:nvPr/>
        </p:nvSpPr>
        <p:spPr>
          <a:xfrm>
            <a:off x="8734937" y="3838415"/>
            <a:ext cx="358757" cy="502037"/>
          </a:xfrm>
          <a:prstGeom prst="downArrow">
            <a:avLst/>
          </a:prstGeom>
          <a:solidFill>
            <a:srgbClr val="1D497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7867C19-8EBA-4B30-861B-F750535AD21D}"/>
              </a:ext>
            </a:extLst>
          </p:cNvPr>
          <p:cNvSpPr txBox="1"/>
          <p:nvPr/>
        </p:nvSpPr>
        <p:spPr>
          <a:xfrm>
            <a:off x="272955" y="5890165"/>
            <a:ext cx="1160080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onclusion: Inhaled sargramostim addition to SOC improved P(A-a)O2 by day 6, a measure of oxygenation, in hospitalized patients with COVID-19-associated acute hypoxemia.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A1160C1-666E-4E97-B28E-4CF06A4CFDA2}"/>
              </a:ext>
            </a:extLst>
          </p:cNvPr>
          <p:cNvSpPr txBox="1"/>
          <p:nvPr/>
        </p:nvSpPr>
        <p:spPr>
          <a:xfrm>
            <a:off x="852062" y="4335396"/>
            <a:ext cx="3036181" cy="1384995"/>
          </a:xfrm>
          <a:prstGeom prst="rect">
            <a:avLst/>
          </a:prstGeom>
          <a:ln>
            <a:solidFill>
              <a:srgbClr val="33BCB7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Greater improvement in P(A-a)O</a:t>
            </a:r>
            <a:r>
              <a:rPr lang="en-US" sz="1600" b="1" baseline="-25000" dirty="0"/>
              <a:t>2</a:t>
            </a:r>
            <a:r>
              <a:rPr lang="en-US" sz="1600" b="1" dirty="0"/>
              <a:t> by day 6 in Sargramostim vs </a:t>
            </a:r>
          </a:p>
          <a:p>
            <a:pPr algn="ctr"/>
            <a:r>
              <a:rPr lang="en-US" sz="1600" b="1" dirty="0"/>
              <a:t>SOC arm </a:t>
            </a:r>
          </a:p>
          <a:p>
            <a:pPr algn="ctr"/>
            <a:r>
              <a:rPr lang="en-US" sz="1200" dirty="0"/>
              <a:t>(n= 96; least squares mean change from baseline (SE): -102.3 (19.4) vs -30.5 (26.9) mmHg; p=0.033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4F27A42-461E-47EC-A4CA-0271E1646E44}"/>
              </a:ext>
            </a:extLst>
          </p:cNvPr>
          <p:cNvSpPr txBox="1"/>
          <p:nvPr/>
        </p:nvSpPr>
        <p:spPr>
          <a:xfrm>
            <a:off x="4190974" y="4349758"/>
            <a:ext cx="2400682" cy="954107"/>
          </a:xfrm>
          <a:prstGeom prst="rect">
            <a:avLst/>
          </a:prstGeom>
          <a:ln>
            <a:solidFill>
              <a:srgbClr val="33BCB7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No difference in intubation rates by day 14</a:t>
            </a:r>
          </a:p>
          <a:p>
            <a:pPr algn="ctr"/>
            <a:r>
              <a:rPr lang="en-US" sz="1200" dirty="0"/>
              <a:t>(11.5% (9/78) of sargramostim and 15.9% (7/44) of SOC arm (p=0.49)) </a:t>
            </a:r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24FC4E8F-3124-4036-9816-9EBA28B0A15C}"/>
              </a:ext>
            </a:extLst>
          </p:cNvPr>
          <p:cNvSpPr/>
          <p:nvPr/>
        </p:nvSpPr>
        <p:spPr>
          <a:xfrm>
            <a:off x="4888861" y="3813838"/>
            <a:ext cx="358757" cy="502037"/>
          </a:xfrm>
          <a:prstGeom prst="downArrow">
            <a:avLst/>
          </a:prstGeom>
          <a:solidFill>
            <a:srgbClr val="1D497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957DE0A-4191-4366-9F0E-39440BF0498A}"/>
              </a:ext>
            </a:extLst>
          </p:cNvPr>
          <p:cNvSpPr txBox="1"/>
          <p:nvPr/>
        </p:nvSpPr>
        <p:spPr>
          <a:xfrm>
            <a:off x="7646874" y="4349758"/>
            <a:ext cx="2534886" cy="1138773"/>
          </a:xfrm>
          <a:prstGeom prst="rect">
            <a:avLst/>
          </a:prstGeom>
          <a:ln>
            <a:solidFill>
              <a:srgbClr val="33BCB7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argramostim was well tolerated</a:t>
            </a:r>
          </a:p>
          <a:p>
            <a:pPr algn="ctr"/>
            <a:r>
              <a:rPr lang="en-US" sz="1200" dirty="0"/>
              <a:t>(67.9% (53/78) of sargramostim and 70.5% (31/44) of SOC arm with treatment-emergent adverse events) 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54B5C8A-81DE-42BA-B115-6DA3138AD492}"/>
              </a:ext>
            </a:extLst>
          </p:cNvPr>
          <p:cNvSpPr txBox="1"/>
          <p:nvPr/>
        </p:nvSpPr>
        <p:spPr>
          <a:xfrm>
            <a:off x="18248" y="6598051"/>
            <a:ext cx="121555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bbreviations: GM-CSF, granulocyte-macrophage colony-stimulating factor; P(A-a)O2, alveolar-arterial oxygen gradient; rhu, recombinant human; SOC, standard of care; SOFA, sequential organ failure assessment</a:t>
            </a:r>
          </a:p>
        </p:txBody>
      </p:sp>
    </p:spTree>
    <p:extLst>
      <p:ext uri="{BB962C8B-B14F-4D97-AF65-F5344CB8AC3E}">
        <p14:creationId xmlns:p14="http://schemas.microsoft.com/office/powerpoint/2010/main" val="2835615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267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yn Ragsdale</dc:creator>
  <cp:lastModifiedBy>Carolyn Ragsdale</cp:lastModifiedBy>
  <cp:revision>1</cp:revision>
  <dcterms:created xsi:type="dcterms:W3CDTF">2022-04-11T15:15:37Z</dcterms:created>
  <dcterms:modified xsi:type="dcterms:W3CDTF">2022-07-28T19:05:57Z</dcterms:modified>
</cp:coreProperties>
</file>